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2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3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2.xml" ContentType="application/vnd.openxmlformats-officedocument.themeOverride+xml"/>
  <Override PartName="/ppt/drawings/drawing4.xml" ContentType="application/vnd.openxmlformats-officedocument.drawingml.chartshapes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4"/>
  </p:notesMasterIdLst>
  <p:sldIdLst>
    <p:sldId id="263" r:id="rId2"/>
    <p:sldId id="257" r:id="rId3"/>
    <p:sldId id="296" r:id="rId4"/>
    <p:sldId id="284" r:id="rId5"/>
    <p:sldId id="285" r:id="rId6"/>
    <p:sldId id="299" r:id="rId7"/>
    <p:sldId id="274" r:id="rId8"/>
    <p:sldId id="288" r:id="rId9"/>
    <p:sldId id="289" r:id="rId10"/>
    <p:sldId id="290" r:id="rId11"/>
    <p:sldId id="292" r:id="rId12"/>
    <p:sldId id="293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266"/>
    <p:restoredTop sz="87232"/>
  </p:normalViewPr>
  <p:slideViewPr>
    <p:cSldViewPr snapToGrid="0" snapToObjects="1">
      <p:cViewPr varScale="1">
        <p:scale>
          <a:sx n="161" d="100"/>
          <a:sy n="161" d="100"/>
        </p:scale>
        <p:origin x="32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oleObject" Target="../embeddings/oleObject1.bin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6.xml"/><Relationship Id="rId1" Type="http://schemas.microsoft.com/office/2011/relationships/chartStyle" Target="style6.xml"/><Relationship Id="rId5" Type="http://schemas.openxmlformats.org/officeDocument/2006/relationships/chartUserShapes" Target="../drawings/drawing4.xml"/><Relationship Id="rId4" Type="http://schemas.openxmlformats.org/officeDocument/2006/relationships/oleObject" Target="../embeddings/oleObject2.bin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Sheet1'!$M$10:$N$10</c:f>
                <c:numCache>
                  <c:formatCode>General</c:formatCode>
                  <c:ptCount val="2"/>
                  <c:pt idx="0">
                    <c:v>0.70945988845975805</c:v>
                  </c:pt>
                  <c:pt idx="1">
                    <c:v>1.02143689640296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Sheet1'!$M$8:$N$8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'[Chart in Microsoft PowerPoint]Sheet1'!$M$9:$N$9</c:f>
              <c:numCache>
                <c:formatCode>General</c:formatCode>
                <c:ptCount val="2"/>
                <c:pt idx="0">
                  <c:v>38.133333333333333</c:v>
                </c:pt>
                <c:pt idx="1">
                  <c:v>8.13333333333333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08-4871-BA16-944A966416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9"/>
        <c:overlap val="-7"/>
        <c:axId val="298340832"/>
        <c:axId val="482713840"/>
      </c:barChart>
      <c:catAx>
        <c:axId val="298340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2713840"/>
        <c:crosses val="autoZero"/>
        <c:auto val="1"/>
        <c:lblAlgn val="ctr"/>
        <c:lblOffset val="100"/>
        <c:noMultiLvlLbl val="0"/>
      </c:catAx>
      <c:valAx>
        <c:axId val="4827138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P-AKT (Ser473)</a:t>
                </a:r>
              </a:p>
              <a:p>
                <a:pPr>
                  <a:defRPr/>
                </a:pPr>
                <a:r>
                  <a:rPr lang="en-US" dirty="0"/>
                  <a:t>% of CD8+ lymphocyt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8340832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/>
              <a:t>IL-9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016094590272266"/>
          <c:y val="0.24896708208016297"/>
          <c:w val="0.73890006624091376"/>
          <c:h val="0.484022203607648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B$13:$C$13</c:f>
                <c:numCache>
                  <c:formatCode>General</c:formatCode>
                  <c:ptCount val="2"/>
                  <c:pt idx="0">
                    <c:v>0.5202563470700442</c:v>
                  </c:pt>
                  <c:pt idx="1">
                    <c:v>0.294392028877594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11:$C$11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Sheet2!$B$12:$C$12</c:f>
              <c:numCache>
                <c:formatCode>General</c:formatCode>
                <c:ptCount val="2"/>
                <c:pt idx="0">
                  <c:v>1.7333333333333334</c:v>
                </c:pt>
                <c:pt idx="1">
                  <c:v>2.86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40-414E-8E68-C21298EA83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overlap val="-27"/>
        <c:axId val="437877064"/>
        <c:axId val="437877720"/>
      </c:barChart>
      <c:catAx>
        <c:axId val="437877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7877720"/>
        <c:crosses val="autoZero"/>
        <c:auto val="1"/>
        <c:lblAlgn val="ctr"/>
        <c:lblOffset val="100"/>
        <c:noMultiLvlLbl val="0"/>
      </c:catAx>
      <c:valAx>
        <c:axId val="437877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of CD8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787706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IFN</a:t>
            </a:r>
            <a:r>
              <a:rPr lang="en-US" sz="1400" b="1" i="0" u="none" strike="noStrike" baseline="0" dirty="0">
                <a:effectLst/>
                <a:sym typeface="Symbol" pitchFamily="2" charset="2"/>
              </a:rPr>
              <a:t></a:t>
            </a:r>
            <a:r>
              <a:rPr lang="en-US" sz="1400" b="0" i="0" u="none" strike="noStrike" baseline="0" dirty="0">
                <a:effectLst/>
              </a:rPr>
              <a:t> </a:t>
            </a:r>
            <a:endParaRPr lang="en-US" sz="1100" dirty="0"/>
          </a:p>
        </c:rich>
      </c:tx>
      <c:layout>
        <c:manualLayout>
          <c:xMode val="edge"/>
          <c:yMode val="edge"/>
          <c:x val="0.43039106145251399"/>
          <c:y val="4.18260185829377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597807711565604"/>
          <c:y val="0.22945792507483173"/>
          <c:w val="0.65897813003577033"/>
          <c:h val="0.533224804503114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44:$C$44</c:f>
                <c:numCache>
                  <c:formatCode>General</c:formatCode>
                  <c:ptCount val="2"/>
                  <c:pt idx="0">
                    <c:v>1.5162453627299173</c:v>
                  </c:pt>
                  <c:pt idx="1">
                    <c:v>3.1816138462526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42:$C$42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Sheet1!$B$43:$C$43</c:f>
              <c:numCache>
                <c:formatCode>General</c:formatCode>
                <c:ptCount val="2"/>
                <c:pt idx="0">
                  <c:v>5.6500000000000012</c:v>
                </c:pt>
                <c:pt idx="1">
                  <c:v>9.36666666666666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3F-B840-BC9F-B0E22CAEF5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overlap val="-27"/>
        <c:axId val="463349088"/>
        <c:axId val="463349416"/>
      </c:barChart>
      <c:catAx>
        <c:axId val="463349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3349416"/>
        <c:crosses val="autoZero"/>
        <c:auto val="1"/>
        <c:lblAlgn val="ctr"/>
        <c:lblOffset val="100"/>
        <c:noMultiLvlLbl val="0"/>
      </c:catAx>
      <c:valAx>
        <c:axId val="4633494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of CD8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334908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IL-9</a:t>
            </a:r>
          </a:p>
        </c:rich>
      </c:tx>
      <c:layout>
        <c:manualLayout>
          <c:xMode val="edge"/>
          <c:yMode val="edge"/>
          <c:x val="0.4675445746482938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0252643000630508"/>
          <c:y val="0.26407491694893176"/>
          <c:w val="0.6155368847050543"/>
          <c:h val="0.436067979742053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74:$C$74</c:f>
                <c:numCache>
                  <c:formatCode>General</c:formatCode>
                  <c:ptCount val="2"/>
                  <c:pt idx="0">
                    <c:v>0.15949921629901578</c:v>
                  </c:pt>
                  <c:pt idx="1">
                    <c:v>0.61877297937127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72:$C$72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Sheet1!$B$73:$C$73</c:f>
              <c:numCache>
                <c:formatCode>General</c:formatCode>
                <c:ptCount val="2"/>
                <c:pt idx="0">
                  <c:v>1.0899999999999999</c:v>
                </c:pt>
                <c:pt idx="1">
                  <c:v>1.85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F8-B346-9708-894BEF144B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overlap val="-27"/>
        <c:axId val="505719720"/>
        <c:axId val="505717424"/>
      </c:barChart>
      <c:catAx>
        <c:axId val="505719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5717424"/>
        <c:crosses val="autoZero"/>
        <c:auto val="1"/>
        <c:lblAlgn val="ctr"/>
        <c:lblOffset val="100"/>
        <c:noMultiLvlLbl val="0"/>
      </c:catAx>
      <c:valAx>
        <c:axId val="505717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of CD8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571972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/>
              <a:t>Thy1.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12:$D$12</c:f>
                <c:numCache>
                  <c:formatCode>General</c:formatCode>
                  <c:ptCount val="2"/>
                  <c:pt idx="0">
                    <c:v>1.1189280584559509</c:v>
                  </c:pt>
                  <c:pt idx="1">
                    <c:v>1.31148770486039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10:$D$10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Sheet1!$C$11:$D$11</c:f>
              <c:numCache>
                <c:formatCode>General</c:formatCode>
                <c:ptCount val="2"/>
                <c:pt idx="0">
                  <c:v>4.3999999999999995</c:v>
                </c:pt>
                <c:pt idx="1">
                  <c:v>6.100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DC-F943-87C9-5A75502DA5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overlap val="-27"/>
        <c:axId val="456470040"/>
        <c:axId val="456478568"/>
      </c:barChart>
      <c:catAx>
        <c:axId val="456470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478568"/>
        <c:crosses val="autoZero"/>
        <c:auto val="1"/>
        <c:lblAlgn val="ctr"/>
        <c:lblOffset val="100"/>
        <c:noMultiLvlLbl val="0"/>
      </c:catAx>
      <c:valAx>
        <c:axId val="456478568"/>
        <c:scaling>
          <c:orientation val="minMax"/>
          <c:max val="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of CD8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470040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CD62L</a:t>
            </a:r>
          </a:p>
        </c:rich>
      </c:tx>
      <c:layout>
        <c:manualLayout>
          <c:xMode val="edge"/>
          <c:yMode val="edge"/>
          <c:x val="0.37896968584428559"/>
          <c:y val="9.52473092635133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0328929968401563"/>
          <c:y val="0.32074215445154947"/>
          <c:w val="0.58622057656704574"/>
          <c:h val="0.397413871126414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115:$C$115</c:f>
                <c:numCache>
                  <c:formatCode>General</c:formatCode>
                  <c:ptCount val="2"/>
                  <c:pt idx="0">
                    <c:v>1.9421637418096291</c:v>
                  </c:pt>
                  <c:pt idx="1">
                    <c:v>4.72680300696640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13:$C$113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Sheet1!$B$114:$C$114</c:f>
              <c:numCache>
                <c:formatCode>General</c:formatCode>
                <c:ptCount val="2"/>
                <c:pt idx="0">
                  <c:v>14.200000000000003</c:v>
                </c:pt>
                <c:pt idx="1">
                  <c:v>19.66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AE-AC44-A9D1-807DC99B4C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overlap val="-27"/>
        <c:axId val="466895840"/>
        <c:axId val="466898792"/>
      </c:barChart>
      <c:catAx>
        <c:axId val="466895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6898792"/>
        <c:crosses val="autoZero"/>
        <c:auto val="1"/>
        <c:lblAlgn val="ctr"/>
        <c:lblOffset val="100"/>
        <c:noMultiLvlLbl val="0"/>
      </c:catAx>
      <c:valAx>
        <c:axId val="4668987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of CD8 </a:t>
                </a:r>
              </a:p>
            </c:rich>
          </c:tx>
          <c:layout>
            <c:manualLayout>
              <c:xMode val="edge"/>
              <c:yMode val="edge"/>
              <c:x val="9.5758107249080113E-2"/>
              <c:y val="0.180811018199704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689584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 err="1"/>
              <a:t>pAKT</a:t>
            </a:r>
            <a:r>
              <a:rPr lang="en-US" sz="1100" dirty="0"/>
              <a:t> (ser473)</a:t>
            </a:r>
          </a:p>
        </c:rich>
      </c:tx>
      <c:layout>
        <c:manualLayout>
          <c:xMode val="edge"/>
          <c:yMode val="edge"/>
          <c:x val="0.32201913551460259"/>
          <c:y val="0.1306692869116850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Sheet1'!$B$28:$C$28</c:f>
                <c:numCache>
                  <c:formatCode>General</c:formatCode>
                  <c:ptCount val="2"/>
                  <c:pt idx="0">
                    <c:v>2.9268868558020231</c:v>
                  </c:pt>
                  <c:pt idx="1">
                    <c:v>3.90064097296841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Sheet1'!$B$26:$C$26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'[Chart in Microsoft PowerPoint]Sheet1'!$B$27:$C$27</c:f>
              <c:numCache>
                <c:formatCode>General</c:formatCode>
                <c:ptCount val="2"/>
                <c:pt idx="0">
                  <c:v>17.833333333333332</c:v>
                </c:pt>
                <c:pt idx="1">
                  <c:v>13.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14-6B4A-98FC-CEC8EA3BD9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overlap val="-27"/>
        <c:axId val="456476600"/>
        <c:axId val="456478896"/>
      </c:barChart>
      <c:catAx>
        <c:axId val="456476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478896"/>
        <c:crosses val="autoZero"/>
        <c:auto val="1"/>
        <c:lblAlgn val="ctr"/>
        <c:lblOffset val="100"/>
        <c:noMultiLvlLbl val="0"/>
      </c:catAx>
      <c:valAx>
        <c:axId val="4564788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of CD8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476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err="1"/>
              <a:t>Eomes</a:t>
            </a:r>
            <a:endParaRPr lang="en-US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2906468368147681"/>
          <c:y val="0.23129630948082527"/>
          <c:w val="0.69381749560928219"/>
          <c:h val="0.5329811227681182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30 days re-stimulation'!$B$31:$C$31</c:f>
                <c:numCache>
                  <c:formatCode>General</c:formatCode>
                  <c:ptCount val="2"/>
                  <c:pt idx="0">
                    <c:v>0.76528861657982516</c:v>
                  </c:pt>
                  <c:pt idx="1">
                    <c:v>0.804155872120993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30 days re-stimulation'!$B$29:$C$29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'30 days re-stimulation'!$B$30:$C$30</c:f>
              <c:numCache>
                <c:formatCode>General</c:formatCode>
                <c:ptCount val="2"/>
                <c:pt idx="0">
                  <c:v>3.9166666666666674</c:v>
                </c:pt>
                <c:pt idx="1">
                  <c:v>5.03333333333333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F7-504F-96BA-333EF35CE2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overlap val="-27"/>
        <c:axId val="345293664"/>
        <c:axId val="345291696"/>
      </c:barChart>
      <c:catAx>
        <c:axId val="345293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5291696"/>
        <c:crosses val="autoZero"/>
        <c:auto val="1"/>
        <c:lblAlgn val="ctr"/>
        <c:lblOffset val="100"/>
        <c:noMultiLvlLbl val="0"/>
      </c:catAx>
      <c:valAx>
        <c:axId val="3452916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of CD8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5293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err="1"/>
              <a:t>Tbet</a:t>
            </a:r>
            <a:endParaRPr lang="en-US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30 days re-stimulation'!$B$47:$C$47</c:f>
                <c:numCache>
                  <c:formatCode>General</c:formatCode>
                  <c:ptCount val="2"/>
                  <c:pt idx="0">
                    <c:v>2.2815930107419842</c:v>
                  </c:pt>
                  <c:pt idx="1">
                    <c:v>2.18632111090754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30 days re-stimulation'!$B$45:$C$45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'30 days re-stimulation'!$B$46:$C$46</c:f>
              <c:numCache>
                <c:formatCode>General</c:formatCode>
                <c:ptCount val="2"/>
                <c:pt idx="0">
                  <c:v>25.783333333333335</c:v>
                </c:pt>
                <c:pt idx="1">
                  <c:v>28.9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8C-7948-8259-0F2BCBA0A7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overlap val="-27"/>
        <c:axId val="441012080"/>
        <c:axId val="441012736"/>
      </c:barChart>
      <c:catAx>
        <c:axId val="441012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1012736"/>
        <c:crosses val="autoZero"/>
        <c:auto val="1"/>
        <c:lblAlgn val="ctr"/>
        <c:lblOffset val="100"/>
        <c:noMultiLvlLbl val="0"/>
      </c:catAx>
      <c:valAx>
        <c:axId val="44101273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of CD8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101208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/>
              <a:t>CD62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30 days re-stimulation'!$P$39:$Q$39</c:f>
                <c:numCache>
                  <c:formatCode>General</c:formatCode>
                  <c:ptCount val="2"/>
                  <c:pt idx="0">
                    <c:v>6.222734466649281</c:v>
                  </c:pt>
                  <c:pt idx="1">
                    <c:v>0.837406711222213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30 days re-stimulation'!$P$37:$Q$37</c:f>
              <c:strCache>
                <c:ptCount val="2"/>
                <c:pt idx="0">
                  <c:v>Control</c:v>
                </c:pt>
                <c:pt idx="1">
                  <c:v>ezetimibe</c:v>
                </c:pt>
              </c:strCache>
            </c:strRef>
          </c:cat>
          <c:val>
            <c:numRef>
              <c:f>'30 days re-stimulation'!$P$38:$Q$38</c:f>
              <c:numCache>
                <c:formatCode>General</c:formatCode>
                <c:ptCount val="2"/>
                <c:pt idx="0">
                  <c:v>57.674999999999997</c:v>
                </c:pt>
                <c:pt idx="1">
                  <c:v>72.2875000000000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E4-1A4C-86E1-1A484380F5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9"/>
        <c:overlap val="-27"/>
        <c:axId val="479928896"/>
        <c:axId val="479942016"/>
      </c:barChart>
      <c:catAx>
        <c:axId val="479928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9942016"/>
        <c:crosses val="autoZero"/>
        <c:auto val="1"/>
        <c:lblAlgn val="ctr"/>
        <c:lblOffset val="100"/>
        <c:noMultiLvlLbl val="0"/>
      </c:catAx>
      <c:valAx>
        <c:axId val="4799420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of CD8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99288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88</cdr:x>
      <cdr:y>0.23168</cdr:y>
    </cdr:from>
    <cdr:to>
      <cdr:x>0.77909</cdr:x>
      <cdr:y>0.23168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E1220BCE-810C-45BB-8605-5DCA7E7D31B8}"/>
            </a:ext>
          </a:extLst>
        </cdr:cNvPr>
        <cdr:cNvCxnSpPr/>
      </cdr:nvCxnSpPr>
      <cdr:spPr>
        <a:xfrm xmlns:a="http://schemas.openxmlformats.org/drawingml/2006/main">
          <a:off x="1256404" y="390594"/>
          <a:ext cx="877094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</cdr:x>
      <cdr:y>0.05943</cdr:y>
    </cdr:from>
    <cdr:to>
      <cdr:x>0.83392</cdr:x>
      <cdr:y>0.60181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80F2AE3-3B79-4071-8FDF-01CF3B420B06}"/>
            </a:ext>
          </a:extLst>
        </cdr:cNvPr>
        <cdr:cNvSpPr txBox="1"/>
      </cdr:nvSpPr>
      <cdr:spPr>
        <a:xfrm xmlns:a="http://schemas.openxmlformats.org/drawingml/2006/main">
          <a:off x="1369219" y="100189"/>
          <a:ext cx="914419" cy="9144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/>
            <a:t>P&lt;0.01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5551</cdr:x>
      <cdr:y>0.45077</cdr:y>
    </cdr:from>
    <cdr:to>
      <cdr:x>0.66635</cdr:x>
      <cdr:y>0.4695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CD576E1A-15DE-45EE-95D5-6E338DA9BC11}"/>
            </a:ext>
          </a:extLst>
        </cdr:cNvPr>
        <cdr:cNvSpPr txBox="1"/>
      </cdr:nvSpPr>
      <cdr:spPr>
        <a:xfrm xmlns:a="http://schemas.openxmlformats.org/drawingml/2006/main">
          <a:off x="1325525" y="1095154"/>
          <a:ext cx="1158949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  <cdr:relSizeAnchor xmlns:cdr="http://schemas.openxmlformats.org/drawingml/2006/chartDrawing">
    <cdr:from>
      <cdr:x>0.35551</cdr:x>
      <cdr:y>0.44201</cdr:y>
    </cdr:from>
    <cdr:to>
      <cdr:x>0.71198</cdr:x>
      <cdr:y>0.44201</cdr:y>
    </cdr:to>
    <cdr:cxnSp macro="">
      <cdr:nvCxnSpPr>
        <cdr:cNvPr id="6" name="Straight Connector 5">
          <a:extLst xmlns:a="http://schemas.openxmlformats.org/drawingml/2006/main">
            <a:ext uri="{FF2B5EF4-FFF2-40B4-BE49-F238E27FC236}">
              <a16:creationId xmlns:a16="http://schemas.microsoft.com/office/drawing/2014/main" id="{2ECF95AE-C98A-4C39-8828-2E30068632EB}"/>
            </a:ext>
          </a:extLst>
        </cdr:cNvPr>
        <cdr:cNvCxnSpPr/>
      </cdr:nvCxnSpPr>
      <cdr:spPr>
        <a:xfrm xmlns:a="http://schemas.openxmlformats.org/drawingml/2006/main">
          <a:off x="1325524" y="1073889"/>
          <a:ext cx="1329070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7737</cdr:x>
      <cdr:y>0.28656</cdr:y>
    </cdr:from>
    <cdr:to>
      <cdr:x>0.62262</cdr:x>
      <cdr:y>0.66292</cdr:y>
    </cdr:to>
    <cdr:sp macro="" textlink="">
      <cdr:nvSpPr>
        <cdr:cNvPr id="7" name="TextBox 6">
          <a:extLst xmlns:a="http://schemas.openxmlformats.org/drawingml/2006/main">
            <a:ext uri="{FF2B5EF4-FFF2-40B4-BE49-F238E27FC236}">
              <a16:creationId xmlns:a16="http://schemas.microsoft.com/office/drawing/2014/main" id="{15BC83DD-376D-413C-BDE0-32FFE301CA00}"/>
            </a:ext>
          </a:extLst>
        </cdr:cNvPr>
        <cdr:cNvSpPr txBox="1"/>
      </cdr:nvSpPr>
      <cdr:spPr>
        <a:xfrm xmlns:a="http://schemas.openxmlformats.org/drawingml/2006/main">
          <a:off x="643414" y="329463"/>
          <a:ext cx="418145" cy="4327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000" dirty="0"/>
            <a:t>P=0.036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39257</cdr:x>
      <cdr:y>0.41771</cdr:y>
    </cdr:from>
    <cdr:to>
      <cdr:x>0.71972</cdr:x>
      <cdr:y>0.41771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23D3E96F-6DE5-4E63-BFF1-242637548F81}"/>
            </a:ext>
          </a:extLst>
        </cdr:cNvPr>
        <cdr:cNvCxnSpPr/>
      </cdr:nvCxnSpPr>
      <cdr:spPr>
        <a:xfrm xmlns:a="http://schemas.openxmlformats.org/drawingml/2006/main">
          <a:off x="840454" y="556958"/>
          <a:ext cx="700389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0945</cdr:x>
      <cdr:y>0.27315</cdr:y>
    </cdr:from>
    <cdr:to>
      <cdr:x>0.75117</cdr:x>
      <cdr:y>0.78812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EAF588F5-9FBB-4AAA-872A-1AC5631FB168}"/>
            </a:ext>
          </a:extLst>
        </cdr:cNvPr>
        <cdr:cNvSpPr txBox="1"/>
      </cdr:nvSpPr>
      <cdr:spPr>
        <a:xfrm xmlns:a="http://schemas.openxmlformats.org/drawingml/2006/main">
          <a:off x="876580" y="364210"/>
          <a:ext cx="731582" cy="6866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/>
            <a:t>P=0.025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49333</cdr:x>
      <cdr:y>0.45031</cdr:y>
    </cdr:from>
    <cdr:to>
      <cdr:x>0.76237</cdr:x>
      <cdr:y>0.45031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927D7996-388C-4497-BBEA-50940B7B1504}"/>
            </a:ext>
          </a:extLst>
        </cdr:cNvPr>
        <cdr:cNvCxnSpPr/>
      </cdr:nvCxnSpPr>
      <cdr:spPr>
        <a:xfrm xmlns:a="http://schemas.openxmlformats.org/drawingml/2006/main">
          <a:off x="927749" y="612733"/>
          <a:ext cx="505953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852</cdr:x>
      <cdr:y>0.28825</cdr:y>
    </cdr:from>
    <cdr:to>
      <cdr:x>0.97144</cdr:x>
      <cdr:y>0.9602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F0D83CA8-471E-4B60-9863-A732F2FF7904}"/>
            </a:ext>
          </a:extLst>
        </cdr:cNvPr>
        <cdr:cNvSpPr txBox="1"/>
      </cdr:nvSpPr>
      <cdr:spPr>
        <a:xfrm xmlns:a="http://schemas.openxmlformats.org/drawingml/2006/main">
          <a:off x="912461" y="392220"/>
          <a:ext cx="914417" cy="9143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P-0.04</a:t>
          </a:r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68A643-0F48-D94A-8450-4D3A08129148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E6FE18-D2F7-C34F-AA82-8B89A5145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0166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- growth of </a:t>
            </a:r>
            <a:r>
              <a:rPr lang="en-US" dirty="0" err="1"/>
              <a:t>sq</a:t>
            </a:r>
            <a:r>
              <a:rPr lang="en-US" dirty="0"/>
              <a:t> tumor after lymphocyte transfer.  The control group didn’t work for </a:t>
            </a:r>
            <a:r>
              <a:rPr lang="en-US"/>
              <a:t>technical reas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E6FE18-D2F7-C34F-AA82-8B89A5145F0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3378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plenocytes from ezetimibe-treated mice showed decreased </a:t>
            </a:r>
            <a:r>
              <a:rPr lang="en-US" dirty="0" err="1"/>
              <a:t>pAKT</a:t>
            </a:r>
            <a:r>
              <a:rPr lang="en-US" dirty="0"/>
              <a:t>(Ser473) in  CD8+ T cells by flow cytometry assay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E6FE18-D2F7-C34F-AA82-8B89A5145F0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9607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E6FE18-D2F7-C34F-AA82-8B89A5145F0E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2824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5295E7-A5D9-6A49-8A17-18166F5F94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978EDC-AF08-7A4C-933D-8BA293D07C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D7F119-7804-E145-883B-802ED411B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402848-A671-7B45-80E0-0601A9252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DCD34-4DB5-0E42-B373-2F643D838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721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647E5E-E94E-9C41-BF1D-C351D63637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519796-5494-244D-82E0-BB5E0F641E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2135E3-F7CC-3849-BEC3-5BD42164F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37FB65-927F-CA48-8369-8DBE76F92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0DD42F-199F-0F4E-A2F4-866DAEBDC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66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75195E-DD51-2E40-A92A-924A2AF5DB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8CDCDB-0B70-7845-A0E4-FF0336306F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772AB1-1834-B344-8655-65F8904F4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C3A784-760F-AC44-AEAB-D84660FDB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69E32A-0B8F-B84F-85BF-285EB47D4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8626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34662F-235D-9841-8FD5-D6E6D9D1B1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0E4D6A-42B3-924D-A460-5FB8ECD0BA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37D305-8C2C-8E4C-8D35-A32CF06D0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04B0DA-1843-C946-854C-BA2AE4F21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96D30F-D7BE-3C4F-B4A2-82E215E6C6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249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139736-FCE0-5B47-8760-795B23D271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DB1FF7-D8EE-5149-B7A6-1BDD0D5807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43CDDC-A851-884D-968D-4D08340C1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631B4F-4BCF-C747-84AE-1096FD8B36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D529F9-C43A-654A-82B0-DFE651A3D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3424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F4665F-2B61-CE49-B886-31C7CBD11D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A5CA51-EC26-164D-88C2-C2FBE85593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53CF3F-3182-A04B-867E-17C9ACCC01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A6A10F-B958-F24E-BDE1-4A7AA85A90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27DD81-473A-BA45-954C-47F578766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7A84AA-E0C5-FB4C-8782-904CDB4F4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471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F0B643-462F-AF49-A817-9C2F61F40B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D275EE-8485-5143-B255-1EAFD895ED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ACA416-83CD-5747-A539-C94EAC2845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316805-359A-1C48-9BBB-29798D18DF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70D86B-13C4-CF41-B73D-CA746CB8DF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F217E1-3BF5-1845-A10A-0FE5D0E596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D1112A-56D9-F74E-95AD-ABC8651A5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823B92B-47CD-284F-897B-FBB9BF17F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98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32B98C-E8A4-B749-B3F8-738CF88777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21B2B5-E582-E64D-9FF0-DCC6594AA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771BF44-B3C7-C84A-97CC-098F3C67C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B347498-D89D-FE41-9A5D-0B7269E84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797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3848864-7DE4-2046-BE68-E60A8909C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2EEC40-D926-7243-A199-8F40D2DFF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F2C412-0BDA-6648-B0D4-16DFC9FE8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991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526DEB-CFE8-554A-BB1F-50AC2E5553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0FB25E-9080-4944-A281-2B33DD7413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2DE2DC-5DDA-C14D-B47F-A103E8C326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8B677B-BC33-2840-A7D7-8BE90550F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952284-3D2C-7840-ABF0-4841AE7CE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3CFFF9-87CC-3A47-8C1F-D442AD2EA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299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11B7BC-7C77-2546-988A-1E7D8999C6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77CDF8F-DB25-4746-84DA-B1C4407E6C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E7E835-2EA1-C04B-911B-2329DAAFF5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C5E5BF-7C57-F144-A9FC-5A7F8823D2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65AF3A-2F43-1E4E-A80F-C2EED4D1D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6E310B-14C0-B348-84DA-EA71217C3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964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7B3D8B0-27C2-7240-8F87-4A59BE74AE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80F5AD-9970-B249-974A-EEE14BC708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9A0C1C-DC5B-AB41-90CD-84BAACA09C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1EE256-3D41-4E4A-87F6-C8A815FD1513}" type="datetimeFigureOut">
              <a:rPr lang="en-US" smtClean="0"/>
              <a:t>12/1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A6A804-6285-B74A-B9AD-7029CFEA9E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31CB78-B83B-C646-8985-A6244CA078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4B571-8B07-4148-A1D0-E146A30F7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743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13" Type="http://schemas.openxmlformats.org/officeDocument/2006/relationships/image" Target="../media/image14.png"/><Relationship Id="rId3" Type="http://schemas.openxmlformats.org/officeDocument/2006/relationships/image" Target="../media/image8.png"/><Relationship Id="rId7" Type="http://schemas.openxmlformats.org/officeDocument/2006/relationships/chart" Target="../charts/chart3.xml"/><Relationship Id="rId12" Type="http://schemas.openxmlformats.org/officeDocument/2006/relationships/image" Target="../media/image13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2.png"/><Relationship Id="rId5" Type="http://schemas.openxmlformats.org/officeDocument/2006/relationships/image" Target="../media/image9.png"/><Relationship Id="rId15" Type="http://schemas.openxmlformats.org/officeDocument/2006/relationships/chart" Target="../charts/chart6.xml"/><Relationship Id="rId10" Type="http://schemas.openxmlformats.org/officeDocument/2006/relationships/image" Target="../media/image11.png"/><Relationship Id="rId4" Type="http://schemas.openxmlformats.org/officeDocument/2006/relationships/chart" Target="../charts/chart2.xml"/><Relationship Id="rId9" Type="http://schemas.openxmlformats.org/officeDocument/2006/relationships/chart" Target="../charts/chart5.xml"/><Relationship Id="rId1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9.xml"/><Relationship Id="rId13" Type="http://schemas.openxmlformats.org/officeDocument/2006/relationships/image" Target="../media/image23.png"/><Relationship Id="rId3" Type="http://schemas.openxmlformats.org/officeDocument/2006/relationships/chart" Target="../charts/chart8.xml"/><Relationship Id="rId7" Type="http://schemas.openxmlformats.org/officeDocument/2006/relationships/image" Target="../media/image19.png"/><Relationship Id="rId12" Type="http://schemas.openxmlformats.org/officeDocument/2006/relationships/image" Target="../media/image22.png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openxmlformats.org/officeDocument/2006/relationships/chart" Target="../charts/chart10.xml"/><Relationship Id="rId5" Type="http://schemas.openxmlformats.org/officeDocument/2006/relationships/image" Target="../media/image17.png"/><Relationship Id="rId10" Type="http://schemas.openxmlformats.org/officeDocument/2006/relationships/image" Target="../media/image21.png"/><Relationship Id="rId4" Type="http://schemas.openxmlformats.org/officeDocument/2006/relationships/image" Target="../media/image16.png"/><Relationship Id="rId9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256CB72-AB82-8B4E-9945-DBCF46D821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6150" y="2012950"/>
            <a:ext cx="5219700" cy="28321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5E021DC-8AA1-5846-B553-CDF3035301C0}"/>
              </a:ext>
            </a:extLst>
          </p:cNvPr>
          <p:cNvSpPr txBox="1"/>
          <p:nvPr/>
        </p:nvSpPr>
        <p:spPr>
          <a:xfrm>
            <a:off x="391886" y="6335486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1</a:t>
            </a:r>
          </a:p>
        </p:txBody>
      </p:sp>
    </p:spTree>
    <p:extLst>
      <p:ext uri="{BB962C8B-B14F-4D97-AF65-F5344CB8AC3E}">
        <p14:creationId xmlns:p14="http://schemas.microsoft.com/office/powerpoint/2010/main" val="41615285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C947308-75F6-054E-A2FB-2235F3F62B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37100" y="1536700"/>
            <a:ext cx="2717800" cy="37846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875022E-A594-0B4B-8968-DDFA19098731}"/>
              </a:ext>
            </a:extLst>
          </p:cNvPr>
          <p:cNvSpPr txBox="1"/>
          <p:nvPr/>
        </p:nvSpPr>
        <p:spPr>
          <a:xfrm>
            <a:off x="391886" y="6335486"/>
            <a:ext cx="2146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10</a:t>
            </a:r>
          </a:p>
        </p:txBody>
      </p:sp>
    </p:spTree>
    <p:extLst>
      <p:ext uri="{BB962C8B-B14F-4D97-AF65-F5344CB8AC3E}">
        <p14:creationId xmlns:p14="http://schemas.microsoft.com/office/powerpoint/2010/main" val="28748515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EF2C5CD-F721-1541-9321-93B59104A4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1155" y="1092777"/>
            <a:ext cx="4495800" cy="44323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6911F0D-6E1E-B845-BA0B-B0D58E0ABD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9163" y="1092777"/>
            <a:ext cx="4572000" cy="45085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15568C6-0016-5E4C-99ED-776AD530931E}"/>
              </a:ext>
            </a:extLst>
          </p:cNvPr>
          <p:cNvSpPr txBox="1"/>
          <p:nvPr/>
        </p:nvSpPr>
        <p:spPr>
          <a:xfrm>
            <a:off x="391886" y="6335486"/>
            <a:ext cx="2146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11</a:t>
            </a:r>
          </a:p>
        </p:txBody>
      </p:sp>
    </p:spTree>
    <p:extLst>
      <p:ext uri="{BB962C8B-B14F-4D97-AF65-F5344CB8AC3E}">
        <p14:creationId xmlns:p14="http://schemas.microsoft.com/office/powerpoint/2010/main" val="133995123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7A0A0FC-CBD9-3C4C-A6A3-3D1120ED96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64548" y="1123950"/>
            <a:ext cx="4470400" cy="46101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48CAEF3-4474-2641-A9B6-D4EFC93DF964}"/>
              </a:ext>
            </a:extLst>
          </p:cNvPr>
          <p:cNvSpPr txBox="1"/>
          <p:nvPr/>
        </p:nvSpPr>
        <p:spPr>
          <a:xfrm>
            <a:off x="391886" y="6335486"/>
            <a:ext cx="2146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12</a:t>
            </a:r>
          </a:p>
        </p:txBody>
      </p:sp>
    </p:spTree>
    <p:extLst>
      <p:ext uri="{BB962C8B-B14F-4D97-AF65-F5344CB8AC3E}">
        <p14:creationId xmlns:p14="http://schemas.microsoft.com/office/powerpoint/2010/main" val="254250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id="{E5DC058C-57D0-432D-BD51-419035E8F90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15" b="12225"/>
          <a:stretch/>
        </p:blipFill>
        <p:spPr bwMode="auto">
          <a:xfrm>
            <a:off x="2717798" y="2429895"/>
            <a:ext cx="1532435" cy="1605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4">
            <a:extLst>
              <a:ext uri="{FF2B5EF4-FFF2-40B4-BE49-F238E27FC236}">
                <a16:creationId xmlns:a16="http://schemas.microsoft.com/office/drawing/2014/main" id="{B4BED03E-3AED-4E19-A33F-C300DCB586E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80" b="12225"/>
          <a:stretch/>
        </p:blipFill>
        <p:spPr bwMode="auto">
          <a:xfrm>
            <a:off x="4430604" y="2429894"/>
            <a:ext cx="1520079" cy="1605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F6384B8-6F96-4531-80D9-D477FCCA131A}"/>
              </a:ext>
            </a:extLst>
          </p:cNvPr>
          <p:cNvSpPr txBox="1"/>
          <p:nvPr/>
        </p:nvSpPr>
        <p:spPr>
          <a:xfrm>
            <a:off x="2966998" y="2060562"/>
            <a:ext cx="27468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                 </a:t>
            </a:r>
            <a:r>
              <a:rPr lang="en-US" dirty="0" err="1"/>
              <a:t>Ezetimible</a:t>
            </a:r>
            <a:endParaRPr lang="en-US" dirty="0"/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9FC6D90B-6E07-4CCB-833C-3DE15DAB84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7483235"/>
              </p:ext>
            </p:extLst>
          </p:nvPr>
        </p:nvGraphicFramePr>
        <p:xfrm>
          <a:off x="6460627" y="2459292"/>
          <a:ext cx="2738438" cy="1685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95E4C308-C81F-41FB-B349-E9558751F629}"/>
              </a:ext>
            </a:extLst>
          </p:cNvPr>
          <p:cNvSpPr txBox="1"/>
          <p:nvPr/>
        </p:nvSpPr>
        <p:spPr>
          <a:xfrm>
            <a:off x="478619" y="5918255"/>
            <a:ext cx="2082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2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CEEFB77-D7AF-464B-9E93-8AF198E1A539}"/>
              </a:ext>
            </a:extLst>
          </p:cNvPr>
          <p:cNvSpPr txBox="1"/>
          <p:nvPr/>
        </p:nvSpPr>
        <p:spPr>
          <a:xfrm>
            <a:off x="3460818" y="4174191"/>
            <a:ext cx="15788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AKT (Ser473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DF6DC1F-C800-7B44-A4FA-5F6D2458CF5E}"/>
              </a:ext>
            </a:extLst>
          </p:cNvPr>
          <p:cNvSpPr txBox="1"/>
          <p:nvPr/>
        </p:nvSpPr>
        <p:spPr>
          <a:xfrm rot="16200000">
            <a:off x="2159055" y="2995913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74B1BCA-A47C-1B4B-BE56-4A523E143892}"/>
              </a:ext>
            </a:extLst>
          </p:cNvPr>
          <p:cNvSpPr txBox="1"/>
          <p:nvPr/>
        </p:nvSpPr>
        <p:spPr>
          <a:xfrm>
            <a:off x="3705728" y="305806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0860E2D-71CD-D146-A1B1-542EC81B83EC}"/>
              </a:ext>
            </a:extLst>
          </p:cNvPr>
          <p:cNvSpPr txBox="1"/>
          <p:nvPr/>
        </p:nvSpPr>
        <p:spPr>
          <a:xfrm>
            <a:off x="5330653" y="3058068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.4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F846B6D-809E-CF43-A6F7-B93449B9C8BE}"/>
              </a:ext>
            </a:extLst>
          </p:cNvPr>
          <p:cNvSpPr/>
          <p:nvPr/>
        </p:nvSpPr>
        <p:spPr>
          <a:xfrm>
            <a:off x="3705728" y="3427400"/>
            <a:ext cx="418704" cy="1620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805E129-8C16-044F-9D0A-09B39A0207E0}"/>
              </a:ext>
            </a:extLst>
          </p:cNvPr>
          <p:cNvSpPr/>
          <p:nvPr/>
        </p:nvSpPr>
        <p:spPr>
          <a:xfrm>
            <a:off x="5340709" y="3394374"/>
            <a:ext cx="418704" cy="1620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0048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5957B48-D1C8-8A44-BDE2-ACF9B3408E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432" r="1" b="12156"/>
          <a:stretch/>
        </p:blipFill>
        <p:spPr>
          <a:xfrm>
            <a:off x="3551888" y="1906526"/>
            <a:ext cx="1681047" cy="173948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B3F4B27-71DF-504F-A0F5-19840169FA0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690" b="12828"/>
          <a:stretch/>
        </p:blipFill>
        <p:spPr>
          <a:xfrm>
            <a:off x="6510326" y="1872376"/>
            <a:ext cx="1632604" cy="170199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98B808A-EA37-D147-AB7D-6B16575F23F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976" b="13133"/>
          <a:stretch/>
        </p:blipFill>
        <p:spPr>
          <a:xfrm>
            <a:off x="9575996" y="1906526"/>
            <a:ext cx="1632604" cy="1701994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4D853553-BC4C-684A-8E1B-2AB64193B925}"/>
              </a:ext>
            </a:extLst>
          </p:cNvPr>
          <p:cNvCxnSpPr>
            <a:cxnSpLocks/>
          </p:cNvCxnSpPr>
          <p:nvPr/>
        </p:nvCxnSpPr>
        <p:spPr>
          <a:xfrm flipV="1">
            <a:off x="3393949" y="1978842"/>
            <a:ext cx="0" cy="18460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C88AB2D-674C-F044-9A9F-4A169FE60F13}"/>
              </a:ext>
            </a:extLst>
          </p:cNvPr>
          <p:cNvCxnSpPr/>
          <p:nvPr/>
        </p:nvCxnSpPr>
        <p:spPr>
          <a:xfrm>
            <a:off x="3393949" y="3824848"/>
            <a:ext cx="184289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9F6C33A0-FA41-F742-BBAD-1F5D67E6C5F4}"/>
              </a:ext>
            </a:extLst>
          </p:cNvPr>
          <p:cNvSpPr txBox="1"/>
          <p:nvPr/>
        </p:nvSpPr>
        <p:spPr>
          <a:xfrm rot="16200000">
            <a:off x="2909360" y="2754441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11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760869C-BBFD-8B43-B3D5-DC7BF9833D0B}"/>
              </a:ext>
            </a:extLst>
          </p:cNvPr>
          <p:cNvSpPr txBox="1"/>
          <p:nvPr/>
        </p:nvSpPr>
        <p:spPr>
          <a:xfrm>
            <a:off x="4100823" y="3824848"/>
            <a:ext cx="5415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SC-A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89AB449E-A0AA-274C-932F-AAF75B9C9860}"/>
              </a:ext>
            </a:extLst>
          </p:cNvPr>
          <p:cNvCxnSpPr>
            <a:cxnSpLocks/>
          </p:cNvCxnSpPr>
          <p:nvPr/>
        </p:nvCxnSpPr>
        <p:spPr>
          <a:xfrm>
            <a:off x="6332225" y="3816705"/>
            <a:ext cx="18107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07F8E87-CEEF-4247-ACB4-8752385C9C47}"/>
              </a:ext>
            </a:extLst>
          </p:cNvPr>
          <p:cNvCxnSpPr>
            <a:cxnSpLocks/>
          </p:cNvCxnSpPr>
          <p:nvPr/>
        </p:nvCxnSpPr>
        <p:spPr>
          <a:xfrm flipH="1" flipV="1">
            <a:off x="6332225" y="1978842"/>
            <a:ext cx="13245" cy="18460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B9EF9D03-B67A-0343-88BE-D98145D2B7A9}"/>
              </a:ext>
            </a:extLst>
          </p:cNvPr>
          <p:cNvSpPr txBox="1"/>
          <p:nvPr/>
        </p:nvSpPr>
        <p:spPr>
          <a:xfrm rot="16200000">
            <a:off x="5907048" y="2832942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11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6731947-9541-9647-BADD-1E5E941894E1}"/>
              </a:ext>
            </a:extLst>
          </p:cNvPr>
          <p:cNvSpPr txBox="1"/>
          <p:nvPr/>
        </p:nvSpPr>
        <p:spPr>
          <a:xfrm>
            <a:off x="6978531" y="3841213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80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CFFE7A63-88FC-B64F-9646-69B4EC31ED04}"/>
              </a:ext>
            </a:extLst>
          </p:cNvPr>
          <p:cNvCxnSpPr>
            <a:cxnSpLocks/>
          </p:cNvCxnSpPr>
          <p:nvPr/>
        </p:nvCxnSpPr>
        <p:spPr>
          <a:xfrm>
            <a:off x="9359435" y="3816705"/>
            <a:ext cx="187082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884DC40-AF71-8D4D-9FC6-E60F7A942CD5}"/>
              </a:ext>
            </a:extLst>
          </p:cNvPr>
          <p:cNvCxnSpPr/>
          <p:nvPr/>
        </p:nvCxnSpPr>
        <p:spPr>
          <a:xfrm flipV="1">
            <a:off x="9359435" y="1978842"/>
            <a:ext cx="0" cy="18378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5A5A7369-9DAF-784F-9233-B7875F69CAEF}"/>
              </a:ext>
            </a:extLst>
          </p:cNvPr>
          <p:cNvSpPr txBox="1"/>
          <p:nvPr/>
        </p:nvSpPr>
        <p:spPr>
          <a:xfrm rot="16200000">
            <a:off x="8945215" y="2832942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11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5E4759A-F2CA-3749-83FA-16C7B09000BD}"/>
              </a:ext>
            </a:extLst>
          </p:cNvPr>
          <p:cNvSpPr txBox="1"/>
          <p:nvPr/>
        </p:nvSpPr>
        <p:spPr>
          <a:xfrm>
            <a:off x="10035801" y="3841213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8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9B652A8-B3B8-E241-8050-0D61CD0FC830}"/>
              </a:ext>
            </a:extLst>
          </p:cNvPr>
          <p:cNvSpPr txBox="1"/>
          <p:nvPr/>
        </p:nvSpPr>
        <p:spPr>
          <a:xfrm>
            <a:off x="4418437" y="2875823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5.0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2CD89EB-4EC3-9840-BD30-7D346725AD37}"/>
              </a:ext>
            </a:extLst>
          </p:cNvPr>
          <p:cNvSpPr/>
          <p:nvPr/>
        </p:nvSpPr>
        <p:spPr>
          <a:xfrm>
            <a:off x="4238126" y="2457014"/>
            <a:ext cx="290401" cy="3297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AE14713-FA47-6E40-8F32-E65AE0A7A509}"/>
              </a:ext>
            </a:extLst>
          </p:cNvPr>
          <p:cNvSpPr/>
          <p:nvPr/>
        </p:nvSpPr>
        <p:spPr>
          <a:xfrm>
            <a:off x="7220890" y="3052763"/>
            <a:ext cx="528959" cy="3297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F701310-B82B-6C4B-AD86-DA909D442F36}"/>
              </a:ext>
            </a:extLst>
          </p:cNvPr>
          <p:cNvSpPr txBox="1"/>
          <p:nvPr/>
        </p:nvSpPr>
        <p:spPr>
          <a:xfrm>
            <a:off x="7235814" y="2971441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1.1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D770B492-B024-1C43-BE16-AEE922434A64}"/>
              </a:ext>
            </a:extLst>
          </p:cNvPr>
          <p:cNvSpPr/>
          <p:nvPr/>
        </p:nvSpPr>
        <p:spPr>
          <a:xfrm>
            <a:off x="10051028" y="3115625"/>
            <a:ext cx="612647" cy="3297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EFED47B-0EBB-8548-B325-356F776BC844}"/>
              </a:ext>
            </a:extLst>
          </p:cNvPr>
          <p:cNvSpPr txBox="1"/>
          <p:nvPr/>
        </p:nvSpPr>
        <p:spPr>
          <a:xfrm>
            <a:off x="10050628" y="3057902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.2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6AA69CA-4C69-9141-92F2-093F06158707}"/>
              </a:ext>
            </a:extLst>
          </p:cNvPr>
          <p:cNvSpPr txBox="1"/>
          <p:nvPr/>
        </p:nvSpPr>
        <p:spPr>
          <a:xfrm>
            <a:off x="478619" y="5918255"/>
            <a:ext cx="2082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3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F4309D8-52B6-5E48-AF00-D85D64E869CB}"/>
              </a:ext>
            </a:extLst>
          </p:cNvPr>
          <p:cNvSpPr/>
          <p:nvPr/>
        </p:nvSpPr>
        <p:spPr>
          <a:xfrm>
            <a:off x="9018357" y="1717118"/>
            <a:ext cx="2945625" cy="27990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8621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D72213D-BA78-E747-8CBA-C4AC051D22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449" b="11594"/>
          <a:stretch/>
        </p:blipFill>
        <p:spPr>
          <a:xfrm rot="10800000" flipH="1" flipV="1">
            <a:off x="4096022" y="1680103"/>
            <a:ext cx="923201" cy="97323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2505373-E152-1F42-A048-12219FEEAF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755" b="13149"/>
          <a:stretch/>
        </p:blipFill>
        <p:spPr>
          <a:xfrm rot="10800000" flipH="1" flipV="1">
            <a:off x="5193016" y="1658547"/>
            <a:ext cx="936243" cy="973233"/>
          </a:xfrm>
          <a:prstGeom prst="rect">
            <a:avLst/>
          </a:prstGeom>
        </p:spPr>
      </p:pic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7F3109B9-AB39-784B-B98E-37F98BE7D7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2282828"/>
              </p:ext>
            </p:extLst>
          </p:nvPr>
        </p:nvGraphicFramePr>
        <p:xfrm>
          <a:off x="6240168" y="1551360"/>
          <a:ext cx="1704975" cy="12145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80C4EB7F-59E5-0644-B910-C1228502C1B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449" b="12527"/>
          <a:stretch/>
        </p:blipFill>
        <p:spPr>
          <a:xfrm>
            <a:off x="4114767" y="2795853"/>
            <a:ext cx="943213" cy="98383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ECF1A11-AC01-5B49-B6CE-B1C952C3DD1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7449" b="12527"/>
          <a:stretch/>
        </p:blipFill>
        <p:spPr>
          <a:xfrm>
            <a:off x="5236795" y="2810009"/>
            <a:ext cx="936243" cy="976568"/>
          </a:xfrm>
          <a:prstGeom prst="rect">
            <a:avLst/>
          </a:prstGeom>
        </p:spPr>
      </p:pic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47179843-64B8-FF42-AEC8-803D50C32D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1679534"/>
              </p:ext>
            </p:extLst>
          </p:nvPr>
        </p:nvGraphicFramePr>
        <p:xfrm>
          <a:off x="6031992" y="2791864"/>
          <a:ext cx="2023067" cy="11141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EA059808-94F3-4C43-A6BE-CB368FDD5E2A}"/>
              </a:ext>
            </a:extLst>
          </p:cNvPr>
          <p:cNvCxnSpPr/>
          <p:nvPr/>
        </p:nvCxnSpPr>
        <p:spPr>
          <a:xfrm>
            <a:off x="6891830" y="2009696"/>
            <a:ext cx="5168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0588AF2F-1479-5C40-A4E3-E21AEC5BAA8E}"/>
              </a:ext>
            </a:extLst>
          </p:cNvPr>
          <p:cNvSpPr txBox="1"/>
          <p:nvPr/>
        </p:nvSpPr>
        <p:spPr>
          <a:xfrm>
            <a:off x="6904424" y="1810809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=0.02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99558EAA-436F-4D42-9273-B313C5F2E41B}"/>
              </a:ext>
            </a:extLst>
          </p:cNvPr>
          <p:cNvCxnSpPr>
            <a:cxnSpLocks/>
          </p:cNvCxnSpPr>
          <p:nvPr/>
        </p:nvCxnSpPr>
        <p:spPr>
          <a:xfrm>
            <a:off x="6855061" y="3249138"/>
            <a:ext cx="57877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C613D12F-E81E-F348-A903-9B16680AAF48}"/>
              </a:ext>
            </a:extLst>
          </p:cNvPr>
          <p:cNvSpPr txBox="1"/>
          <p:nvPr/>
        </p:nvSpPr>
        <p:spPr>
          <a:xfrm>
            <a:off x="6815031" y="3025364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=0.015</a:t>
            </a:r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D2A8AEAE-84B2-2E4E-B7C7-011B757E06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4215866"/>
              </p:ext>
            </p:extLst>
          </p:nvPr>
        </p:nvGraphicFramePr>
        <p:xfrm>
          <a:off x="6075161" y="416168"/>
          <a:ext cx="2019847" cy="12508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4524C7DE-431A-E04A-BD60-8C9C6D39B9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7231408"/>
              </p:ext>
            </p:extLst>
          </p:nvPr>
        </p:nvGraphicFramePr>
        <p:xfrm>
          <a:off x="6069446" y="5014347"/>
          <a:ext cx="2140881" cy="13333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pic>
        <p:nvPicPr>
          <p:cNvPr id="14" name="Picture 13">
            <a:extLst>
              <a:ext uri="{FF2B5EF4-FFF2-40B4-BE49-F238E27FC236}">
                <a16:creationId xmlns:a16="http://schemas.microsoft.com/office/drawing/2014/main" id="{4B1498C3-1D4B-F744-A467-B59ED704A2F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6874" b="10513"/>
          <a:stretch/>
        </p:blipFill>
        <p:spPr>
          <a:xfrm>
            <a:off x="4077715" y="567302"/>
            <a:ext cx="944665" cy="100107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56390E7-A616-C247-9354-207B474E690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5697" b="11974"/>
          <a:stretch/>
        </p:blipFill>
        <p:spPr>
          <a:xfrm>
            <a:off x="5181307" y="590453"/>
            <a:ext cx="936377" cy="94002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73719863-0256-6E44-95F5-FD76B37C4D7E}"/>
              </a:ext>
            </a:extLst>
          </p:cNvPr>
          <p:cNvSpPr txBox="1"/>
          <p:nvPr/>
        </p:nvSpPr>
        <p:spPr>
          <a:xfrm>
            <a:off x="4276030" y="327350"/>
            <a:ext cx="18532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ntrol                   Ezetimibe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296752C5-8695-E44F-A926-F51A28490178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7455" b="12657"/>
          <a:stretch/>
        </p:blipFill>
        <p:spPr>
          <a:xfrm>
            <a:off x="5265685" y="5058418"/>
            <a:ext cx="948580" cy="98803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E1AB61C1-B34C-D24A-86EF-CDD41213C2E4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7455" b="12295"/>
          <a:stretch/>
        </p:blipFill>
        <p:spPr>
          <a:xfrm>
            <a:off x="4120358" y="5067561"/>
            <a:ext cx="944667" cy="98803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F471FD2-22AB-8E4F-8FDA-98D9CAFD24AD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19325" r="52202" b="5828"/>
          <a:stretch/>
        </p:blipFill>
        <p:spPr>
          <a:xfrm>
            <a:off x="4119171" y="3848751"/>
            <a:ext cx="2101006" cy="1081449"/>
          </a:xfrm>
          <a:prstGeom prst="rect">
            <a:avLst/>
          </a:prstGeom>
        </p:spPr>
      </p:pic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68307B70-29F2-BA4D-8557-9F4ED9C2E5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6610911"/>
              </p:ext>
            </p:extLst>
          </p:nvPr>
        </p:nvGraphicFramePr>
        <p:xfrm>
          <a:off x="6132896" y="3759818"/>
          <a:ext cx="1880587" cy="1360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F2FD1E6F-E774-7648-8DF1-CE8767D24EBA}"/>
              </a:ext>
            </a:extLst>
          </p:cNvPr>
          <p:cNvSpPr txBox="1"/>
          <p:nvPr/>
        </p:nvSpPr>
        <p:spPr>
          <a:xfrm>
            <a:off x="391886" y="6335486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144A24A-CC26-B346-B28C-A1AA8B344CA1}"/>
              </a:ext>
            </a:extLst>
          </p:cNvPr>
          <p:cNvSpPr txBox="1"/>
          <p:nvPr/>
        </p:nvSpPr>
        <p:spPr>
          <a:xfrm rot="16200000">
            <a:off x="3476171" y="295365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D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0E62593-212C-1349-88FF-D659A7AD9E89}"/>
              </a:ext>
            </a:extLst>
          </p:cNvPr>
          <p:cNvSpPr txBox="1"/>
          <p:nvPr/>
        </p:nvSpPr>
        <p:spPr>
          <a:xfrm>
            <a:off x="4491968" y="6136809"/>
            <a:ext cx="1421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mmune markers</a:t>
            </a:r>
          </a:p>
        </p:txBody>
      </p:sp>
    </p:spTree>
    <p:extLst>
      <p:ext uri="{BB962C8B-B14F-4D97-AF65-F5344CB8AC3E}">
        <p14:creationId xmlns:p14="http://schemas.microsoft.com/office/powerpoint/2010/main" val="1296165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1A3720EC-E8E9-A74F-8D76-080032FB05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5813856"/>
              </p:ext>
            </p:extLst>
          </p:nvPr>
        </p:nvGraphicFramePr>
        <p:xfrm>
          <a:off x="5416693" y="1552592"/>
          <a:ext cx="2140880" cy="15731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2D235F8-57FA-964D-B24F-0858A0012B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4266846"/>
              </p:ext>
            </p:extLst>
          </p:nvPr>
        </p:nvGraphicFramePr>
        <p:xfrm>
          <a:off x="5395032" y="2904091"/>
          <a:ext cx="2140880" cy="13006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EA2CF16A-4053-984E-894F-0B13B39336A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633" b="12540"/>
          <a:stretch/>
        </p:blipFill>
        <p:spPr>
          <a:xfrm>
            <a:off x="3330513" y="1733561"/>
            <a:ext cx="874814" cy="914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A30A679-2F06-DD42-98E4-46BF065A4BD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633" b="12222"/>
          <a:stretch/>
        </p:blipFill>
        <p:spPr>
          <a:xfrm>
            <a:off x="3345106" y="2958234"/>
            <a:ext cx="871650" cy="914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97D68CE-91E1-4243-AC08-8E0285C30A7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7633" b="12222"/>
          <a:stretch/>
        </p:blipFill>
        <p:spPr>
          <a:xfrm>
            <a:off x="4406638" y="1741964"/>
            <a:ext cx="871650" cy="914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617381D-E49C-7F4F-854B-D40C13DE275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7633" b="13175"/>
          <a:stretch/>
        </p:blipFill>
        <p:spPr>
          <a:xfrm>
            <a:off x="4397636" y="2968333"/>
            <a:ext cx="871479" cy="904301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A0A505A5-66D8-A844-A000-93A23BDC23E3}"/>
              </a:ext>
            </a:extLst>
          </p:cNvPr>
          <p:cNvCxnSpPr/>
          <p:nvPr/>
        </p:nvCxnSpPr>
        <p:spPr>
          <a:xfrm>
            <a:off x="6237709" y="2090383"/>
            <a:ext cx="76339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675C26B3-778F-4943-8E1E-0E5FE3BEE860}"/>
              </a:ext>
            </a:extLst>
          </p:cNvPr>
          <p:cNvSpPr txBox="1"/>
          <p:nvPr/>
        </p:nvSpPr>
        <p:spPr>
          <a:xfrm>
            <a:off x="6237709" y="1909479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=0.03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FFC0ED-6ADC-0F41-A64A-477E20B0A650}"/>
              </a:ext>
            </a:extLst>
          </p:cNvPr>
          <p:cNvSpPr txBox="1"/>
          <p:nvPr/>
        </p:nvSpPr>
        <p:spPr>
          <a:xfrm>
            <a:off x="6407736" y="3244513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=0036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F531A632-8641-E44C-B7BA-0CADFB0F1012}"/>
              </a:ext>
            </a:extLst>
          </p:cNvPr>
          <p:cNvCxnSpPr/>
          <p:nvPr/>
        </p:nvCxnSpPr>
        <p:spPr>
          <a:xfrm>
            <a:off x="6316456" y="3461995"/>
            <a:ext cx="64267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23013CB9-3495-A949-8BD6-1AC8892C19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2742770"/>
              </p:ext>
            </p:extLst>
          </p:nvPr>
        </p:nvGraphicFramePr>
        <p:xfrm>
          <a:off x="5322391" y="4140640"/>
          <a:ext cx="2140881" cy="13333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C273C605-4C86-FE4B-B47C-4BA307743641}"/>
              </a:ext>
            </a:extLst>
          </p:cNvPr>
          <p:cNvSpPr txBox="1"/>
          <p:nvPr/>
        </p:nvSpPr>
        <p:spPr>
          <a:xfrm>
            <a:off x="3355376" y="345586"/>
            <a:ext cx="2330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ntrol                  Ezetimibe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D9BD4826-D58E-F847-B757-DEF0C803E79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7633" b="12205"/>
          <a:stretch/>
        </p:blipFill>
        <p:spPr>
          <a:xfrm>
            <a:off x="3343367" y="4216051"/>
            <a:ext cx="871478" cy="9144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30A203B-AB5F-9543-ACCA-196D375D2B3F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7633" b="12205"/>
          <a:stretch/>
        </p:blipFill>
        <p:spPr>
          <a:xfrm>
            <a:off x="4375058" y="4204762"/>
            <a:ext cx="871478" cy="914400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48C06955-DFE3-FC4F-92C0-3D8488D06DD8}"/>
              </a:ext>
            </a:extLst>
          </p:cNvPr>
          <p:cNvCxnSpPr>
            <a:cxnSpLocks/>
          </p:cNvCxnSpPr>
          <p:nvPr/>
        </p:nvCxnSpPr>
        <p:spPr>
          <a:xfrm>
            <a:off x="6353736" y="4670121"/>
            <a:ext cx="71645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99A3FABC-EA38-DB49-B569-83597F893009}"/>
              </a:ext>
            </a:extLst>
          </p:cNvPr>
          <p:cNvSpPr txBox="1"/>
          <p:nvPr/>
        </p:nvSpPr>
        <p:spPr>
          <a:xfrm>
            <a:off x="6308926" y="4461072"/>
            <a:ext cx="8066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=0.000002</a:t>
            </a:r>
          </a:p>
        </p:txBody>
      </p:sp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672CA26B-98C9-5143-8F03-3B32948800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5579364"/>
              </p:ext>
            </p:extLst>
          </p:nvPr>
        </p:nvGraphicFramePr>
        <p:xfrm>
          <a:off x="5437415" y="339027"/>
          <a:ext cx="2140880" cy="1336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pic>
        <p:nvPicPr>
          <p:cNvPr id="19" name="Picture 18">
            <a:extLst>
              <a:ext uri="{FF2B5EF4-FFF2-40B4-BE49-F238E27FC236}">
                <a16:creationId xmlns:a16="http://schemas.microsoft.com/office/drawing/2014/main" id="{DC5687DE-78DB-EA4E-A25A-6391194ABDD9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6522" b="12788"/>
          <a:stretch/>
        </p:blipFill>
        <p:spPr>
          <a:xfrm>
            <a:off x="3331993" y="604340"/>
            <a:ext cx="889146" cy="9144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E39450BC-6E0C-484D-B3CE-E5CD3FC1F47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6522" b="13534"/>
          <a:stretch/>
        </p:blipFill>
        <p:spPr>
          <a:xfrm>
            <a:off x="4406638" y="604340"/>
            <a:ext cx="896802" cy="914400"/>
          </a:xfrm>
          <a:prstGeom prst="rect">
            <a:avLst/>
          </a:prstGeom>
        </p:spPr>
      </p:pic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3750A37-152B-8D48-B6B9-016D28359C07}"/>
              </a:ext>
            </a:extLst>
          </p:cNvPr>
          <p:cNvCxnSpPr>
            <a:cxnSpLocks/>
          </p:cNvCxnSpPr>
          <p:nvPr/>
        </p:nvCxnSpPr>
        <p:spPr>
          <a:xfrm>
            <a:off x="6075832" y="833331"/>
            <a:ext cx="9675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7490E09C-D0FC-5B4E-B60A-CF70BA4B64FE}"/>
              </a:ext>
            </a:extLst>
          </p:cNvPr>
          <p:cNvSpPr txBox="1"/>
          <p:nvPr/>
        </p:nvSpPr>
        <p:spPr>
          <a:xfrm>
            <a:off x="6135741" y="642554"/>
            <a:ext cx="7834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=0.0009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60DD9DD-0727-B240-AA39-AC8611D1BA28}"/>
              </a:ext>
            </a:extLst>
          </p:cNvPr>
          <p:cNvSpPr txBox="1"/>
          <p:nvPr/>
        </p:nvSpPr>
        <p:spPr>
          <a:xfrm>
            <a:off x="391886" y="6335486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CD60D1F-D8EB-C64A-9027-9910D30CC34A}"/>
              </a:ext>
            </a:extLst>
          </p:cNvPr>
          <p:cNvSpPr txBox="1"/>
          <p:nvPr/>
        </p:nvSpPr>
        <p:spPr>
          <a:xfrm rot="16200000">
            <a:off x="2625135" y="280189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D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FF62F63-2951-3348-BEF3-AC7BC95FD8F3}"/>
              </a:ext>
            </a:extLst>
          </p:cNvPr>
          <p:cNvSpPr txBox="1"/>
          <p:nvPr/>
        </p:nvSpPr>
        <p:spPr>
          <a:xfrm>
            <a:off x="3504169" y="5286835"/>
            <a:ext cx="1421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mmune markers</a:t>
            </a:r>
          </a:p>
        </p:txBody>
      </p:sp>
    </p:spTree>
    <p:extLst>
      <p:ext uri="{BB962C8B-B14F-4D97-AF65-F5344CB8AC3E}">
        <p14:creationId xmlns:p14="http://schemas.microsoft.com/office/powerpoint/2010/main" val="28073732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25D9D57-F535-1F4E-9462-C9B5B1A018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6550" y="863600"/>
            <a:ext cx="8978900" cy="51308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50EB1F2-F14F-CC45-85C5-905774AEBCFE}"/>
              </a:ext>
            </a:extLst>
          </p:cNvPr>
          <p:cNvSpPr txBox="1"/>
          <p:nvPr/>
        </p:nvSpPr>
        <p:spPr>
          <a:xfrm>
            <a:off x="391886" y="6335486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6</a:t>
            </a:r>
          </a:p>
        </p:txBody>
      </p:sp>
    </p:spTree>
    <p:extLst>
      <p:ext uri="{BB962C8B-B14F-4D97-AF65-F5344CB8AC3E}">
        <p14:creationId xmlns:p14="http://schemas.microsoft.com/office/powerpoint/2010/main" val="31475654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5BC712F-0484-457D-88F3-CB2A38E484DB}"/>
              </a:ext>
            </a:extLst>
          </p:cNvPr>
          <p:cNvSpPr txBox="1"/>
          <p:nvPr/>
        </p:nvSpPr>
        <p:spPr>
          <a:xfrm>
            <a:off x="6419044" y="1992309"/>
            <a:ext cx="10608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ictor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l/Fl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82218169-FE75-4BCB-86CB-FFE1B8410799}"/>
              </a:ext>
            </a:extLst>
          </p:cNvPr>
          <p:cNvCxnSpPr>
            <a:cxnSpLocks/>
          </p:cNvCxnSpPr>
          <p:nvPr/>
        </p:nvCxnSpPr>
        <p:spPr>
          <a:xfrm flipH="1">
            <a:off x="6096000" y="2176975"/>
            <a:ext cx="29364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>
            <a:extLst>
              <a:ext uri="{FF2B5EF4-FFF2-40B4-BE49-F238E27FC236}">
                <a16:creationId xmlns:a16="http://schemas.microsoft.com/office/drawing/2014/main" id="{4508747A-5219-4836-BCB6-61F721C478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11664" y="3193599"/>
            <a:ext cx="377985" cy="22297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0D336C2-4097-40FF-8438-B972A75743EE}"/>
              </a:ext>
            </a:extLst>
          </p:cNvPr>
          <p:cNvSpPr txBox="1"/>
          <p:nvPr/>
        </p:nvSpPr>
        <p:spPr>
          <a:xfrm>
            <a:off x="6389649" y="3059668"/>
            <a:ext cx="5006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re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E34244F-D540-4DCC-9D34-C6FB2C1CC579}"/>
              </a:ext>
            </a:extLst>
          </p:cNvPr>
          <p:cNvSpPr txBox="1"/>
          <p:nvPr/>
        </p:nvSpPr>
        <p:spPr>
          <a:xfrm>
            <a:off x="5411885" y="1394255"/>
            <a:ext cx="577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  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74D351F-28AE-4F69-B055-5DB7AB651560}"/>
              </a:ext>
            </a:extLst>
          </p:cNvPr>
          <p:cNvSpPr txBox="1"/>
          <p:nvPr/>
        </p:nvSpPr>
        <p:spPr>
          <a:xfrm>
            <a:off x="8408019" y="1992309"/>
            <a:ext cx="260938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ictor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l/Fl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,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ck-cr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+ (T-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ictor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/-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ictor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l/Fl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,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ck-cr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B1EE037-4BBA-419A-B14A-A2A2210C70DE}"/>
              </a:ext>
            </a:extLst>
          </p:cNvPr>
          <p:cNvSpPr txBox="1"/>
          <p:nvPr/>
        </p:nvSpPr>
        <p:spPr>
          <a:xfrm>
            <a:off x="3423424" y="334537"/>
            <a:ext cx="39769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lvl="0" indent="-342900">
              <a:buFontTx/>
              <a:buAutoNum type="arabicPeriod"/>
              <a:defRPr/>
            </a:pPr>
            <a:r>
              <a:rPr lang="en-US" dirty="0"/>
              <a:t>Genotyping </a:t>
            </a:r>
            <a:r>
              <a:rPr lang="en-US" dirty="0" err="1">
                <a:solidFill>
                  <a:prstClr val="black"/>
                </a:solidFill>
              </a:rPr>
              <a:t>Rictor</a:t>
            </a:r>
            <a:r>
              <a:rPr lang="en-US" dirty="0">
                <a:solidFill>
                  <a:prstClr val="black"/>
                </a:solidFill>
              </a:rPr>
              <a:t> </a:t>
            </a:r>
            <a:r>
              <a:rPr lang="en-US" baseline="30000" dirty="0">
                <a:solidFill>
                  <a:prstClr val="black"/>
                </a:solidFill>
              </a:rPr>
              <a:t>Fl/Fl </a:t>
            </a:r>
            <a:r>
              <a:rPr lang="en-US" dirty="0">
                <a:solidFill>
                  <a:prstClr val="black"/>
                </a:solidFill>
              </a:rPr>
              <a:t>, </a:t>
            </a:r>
            <a:r>
              <a:rPr lang="en-US" dirty="0" err="1">
                <a:solidFill>
                  <a:prstClr val="black"/>
                </a:solidFill>
              </a:rPr>
              <a:t>Lck-cre</a:t>
            </a:r>
            <a:r>
              <a:rPr lang="en-US" dirty="0">
                <a:solidFill>
                  <a:prstClr val="black"/>
                </a:solidFill>
              </a:rPr>
              <a:t>+ mice</a:t>
            </a:r>
          </a:p>
          <a:p>
            <a:r>
              <a:rPr lang="en-US" dirty="0"/>
              <a:t> 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7C3B6A0-C4F4-482E-918D-530D976AF389}"/>
              </a:ext>
            </a:extLst>
          </p:cNvPr>
          <p:cNvGrpSpPr/>
          <p:nvPr/>
        </p:nvGrpSpPr>
        <p:grpSpPr>
          <a:xfrm>
            <a:off x="4926522" y="1709499"/>
            <a:ext cx="1128830" cy="896190"/>
            <a:chOff x="7479912" y="3412199"/>
            <a:chExt cx="1128830" cy="89619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27962FA-8055-441D-8DA2-37E584EA12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71613"/>
            <a:stretch/>
          </p:blipFill>
          <p:spPr>
            <a:xfrm>
              <a:off x="7479912" y="3412199"/>
              <a:ext cx="392849" cy="89619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1306C72-59E8-44DC-BEF9-D9BE194D90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6819" b="68"/>
            <a:stretch/>
          </p:blipFill>
          <p:spPr>
            <a:xfrm>
              <a:off x="7872761" y="3412199"/>
              <a:ext cx="735981" cy="895582"/>
            </a:xfrm>
            <a:prstGeom prst="rect">
              <a:avLst/>
            </a:prstGeom>
          </p:spPr>
        </p:pic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E820F627-9F27-4E09-9EE4-810E90FBAF99}"/>
              </a:ext>
            </a:extLst>
          </p:cNvPr>
          <p:cNvGrpSpPr/>
          <p:nvPr/>
        </p:nvGrpSpPr>
        <p:grpSpPr>
          <a:xfrm>
            <a:off x="4916470" y="2771784"/>
            <a:ext cx="1095194" cy="1123855"/>
            <a:chOff x="5861244" y="4496360"/>
            <a:chExt cx="1095194" cy="1123855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67E4768-CBD5-4B3C-8B61-8A3ABA3252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72687" b="5549"/>
            <a:stretch/>
          </p:blipFill>
          <p:spPr>
            <a:xfrm>
              <a:off x="5861244" y="4496360"/>
              <a:ext cx="400190" cy="1024216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2C64CA0C-0A63-4B11-8184-20F6E7DFC8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0000" b="-8180"/>
            <a:stretch/>
          </p:blipFill>
          <p:spPr>
            <a:xfrm>
              <a:off x="6261434" y="4496360"/>
              <a:ext cx="695004" cy="1123855"/>
            </a:xfrm>
            <a:prstGeom prst="rect">
              <a:avLst/>
            </a:prstGeom>
          </p:spPr>
        </p:pic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9745406D-63B7-8E40-BF1E-C5F13DFCF2C1}"/>
              </a:ext>
            </a:extLst>
          </p:cNvPr>
          <p:cNvSpPr txBox="1"/>
          <p:nvPr/>
        </p:nvSpPr>
        <p:spPr>
          <a:xfrm>
            <a:off x="391886" y="6335486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7</a:t>
            </a:r>
          </a:p>
        </p:txBody>
      </p:sp>
    </p:spTree>
    <p:extLst>
      <p:ext uri="{BB962C8B-B14F-4D97-AF65-F5344CB8AC3E}">
        <p14:creationId xmlns:p14="http://schemas.microsoft.com/office/powerpoint/2010/main" val="18590668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87AB4A9-7457-ED44-B110-9A4585B187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727" t="19420" r="-5075" b="1777"/>
          <a:stretch/>
        </p:blipFill>
        <p:spPr>
          <a:xfrm>
            <a:off x="2167728" y="1596124"/>
            <a:ext cx="2875720" cy="295736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4ABEBD7-5D32-D148-8370-BBB788E597C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513" t="16782" b="4908"/>
          <a:stretch/>
        </p:blipFill>
        <p:spPr>
          <a:xfrm>
            <a:off x="5313418" y="1596124"/>
            <a:ext cx="2648086" cy="278295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142BE9E-F0A1-F44E-A693-08F3ECAE8483}"/>
              </a:ext>
            </a:extLst>
          </p:cNvPr>
          <p:cNvSpPr txBox="1"/>
          <p:nvPr/>
        </p:nvSpPr>
        <p:spPr>
          <a:xfrm>
            <a:off x="3446387" y="1325217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3DFDA22-F418-034E-AF68-F34BB43BC2F3}"/>
              </a:ext>
            </a:extLst>
          </p:cNvPr>
          <p:cNvSpPr txBox="1"/>
          <p:nvPr/>
        </p:nvSpPr>
        <p:spPr>
          <a:xfrm>
            <a:off x="6492862" y="1299064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D8</a:t>
            </a:r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6B5AC7C-64B6-F34B-9405-AA3531821A4B}"/>
              </a:ext>
            </a:extLst>
          </p:cNvPr>
          <p:cNvSpPr/>
          <p:nvPr/>
        </p:nvSpPr>
        <p:spPr>
          <a:xfrm>
            <a:off x="3178076" y="2265198"/>
            <a:ext cx="11044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err="1"/>
              <a:t>Rictor</a:t>
            </a:r>
            <a:r>
              <a:rPr lang="en-US" dirty="0"/>
              <a:t> KO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1F5B8D0-B4A3-FD43-A395-7AE383E412E4}"/>
              </a:ext>
            </a:extLst>
          </p:cNvPr>
          <p:cNvSpPr/>
          <p:nvPr/>
        </p:nvSpPr>
        <p:spPr>
          <a:xfrm>
            <a:off x="3353244" y="3065890"/>
            <a:ext cx="127272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err="1"/>
              <a:t>Rictor</a:t>
            </a:r>
            <a:r>
              <a:rPr lang="en-US" dirty="0"/>
              <a:t> KO +</a:t>
            </a:r>
          </a:p>
          <a:p>
            <a:r>
              <a:rPr lang="el-GR" dirty="0">
                <a:solidFill>
                  <a:prstClr val="black"/>
                </a:solidFill>
              </a:rPr>
              <a:t>β</a:t>
            </a:r>
            <a:r>
              <a:rPr lang="en-US" dirty="0">
                <a:solidFill>
                  <a:prstClr val="black"/>
                </a:solidFill>
              </a:rPr>
              <a:t>CD</a:t>
            </a:r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840246A-253F-8542-B8CA-ACE4C32061BE}"/>
              </a:ext>
            </a:extLst>
          </p:cNvPr>
          <p:cNvSpPr/>
          <p:nvPr/>
        </p:nvSpPr>
        <p:spPr>
          <a:xfrm>
            <a:off x="6381174" y="2249747"/>
            <a:ext cx="11044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err="1"/>
              <a:t>Rictor</a:t>
            </a:r>
            <a:r>
              <a:rPr lang="en-US" dirty="0"/>
              <a:t> KO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4B9EBE5-D9B0-E447-AFA3-DC84AA4B9B64}"/>
              </a:ext>
            </a:extLst>
          </p:cNvPr>
          <p:cNvSpPr/>
          <p:nvPr/>
        </p:nvSpPr>
        <p:spPr>
          <a:xfrm>
            <a:off x="6556342" y="3050439"/>
            <a:ext cx="127272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err="1"/>
              <a:t>Rictor</a:t>
            </a:r>
            <a:r>
              <a:rPr lang="en-US" dirty="0"/>
              <a:t> KO +</a:t>
            </a:r>
          </a:p>
          <a:p>
            <a:r>
              <a:rPr lang="el-GR" dirty="0">
                <a:solidFill>
                  <a:prstClr val="black"/>
                </a:solidFill>
              </a:rPr>
              <a:t>β</a:t>
            </a:r>
            <a:r>
              <a:rPr lang="en-US" dirty="0">
                <a:solidFill>
                  <a:prstClr val="black"/>
                </a:solidFill>
              </a:rPr>
              <a:t>CD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652FE8-B741-5A49-A060-A5D00A72F363}"/>
              </a:ext>
            </a:extLst>
          </p:cNvPr>
          <p:cNvSpPr txBox="1"/>
          <p:nvPr/>
        </p:nvSpPr>
        <p:spPr>
          <a:xfrm>
            <a:off x="391886" y="6335486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8</a:t>
            </a:r>
          </a:p>
        </p:txBody>
      </p:sp>
    </p:spTree>
    <p:extLst>
      <p:ext uri="{BB962C8B-B14F-4D97-AF65-F5344CB8AC3E}">
        <p14:creationId xmlns:p14="http://schemas.microsoft.com/office/powerpoint/2010/main" val="12264914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9CF2DF6-8853-BC4B-9390-0BB73A1E2B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5773" y="1514447"/>
            <a:ext cx="3530600" cy="33274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AA7AAE1-A9FC-CA47-9A6E-878ADADE2818}"/>
              </a:ext>
            </a:extLst>
          </p:cNvPr>
          <p:cNvSpPr txBox="1"/>
          <p:nvPr/>
        </p:nvSpPr>
        <p:spPr>
          <a:xfrm>
            <a:off x="391886" y="6335486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9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E186AC6-986B-2248-BBEA-1041B66E9729}"/>
              </a:ext>
            </a:extLst>
          </p:cNvPr>
          <p:cNvSpPr txBox="1"/>
          <p:nvPr/>
        </p:nvSpPr>
        <p:spPr>
          <a:xfrm rot="16200000">
            <a:off x="2992577" y="2731626"/>
            <a:ext cx="737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Ricto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6705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371</TotalTime>
  <Words>248</Words>
  <Application>Microsoft Macintosh PowerPoint</Application>
  <PresentationFormat>Widescreen</PresentationFormat>
  <Paragraphs>85</Paragraphs>
  <Slides>12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yung Kim</dc:creator>
  <cp:lastModifiedBy>KIM, HYUNG M.D. (UROLOGY)</cp:lastModifiedBy>
  <cp:revision>135</cp:revision>
  <cp:lastPrinted>2019-03-12T21:45:03Z</cp:lastPrinted>
  <dcterms:created xsi:type="dcterms:W3CDTF">2019-03-02T20:14:48Z</dcterms:created>
  <dcterms:modified xsi:type="dcterms:W3CDTF">2020-12-17T04:38:42Z</dcterms:modified>
</cp:coreProperties>
</file>